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71" r:id="rId2"/>
    <p:sldId id="270" r:id="rId3"/>
  </p:sldIdLst>
  <p:sldSz cx="7315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8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549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730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94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278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30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659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41551"/>
            <a:ext cx="3109913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340100"/>
            <a:ext cx="310991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84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613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130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16569"/>
            <a:ext cx="3703320" cy="649816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880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16569"/>
            <a:ext cx="3703320" cy="649816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27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168D7-BC9F-4233-B572-2623F6682C66}" type="datetimeFigureOut">
              <a:rPr lang="en-US" smtClean="0"/>
              <a:t>4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982DD1-7F75-4E7E-984D-AE048DCC4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04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51CE39D-0D06-4FDE-836F-305DD33AE3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4163604"/>
              </p:ext>
            </p:extLst>
          </p:nvPr>
        </p:nvGraphicFramePr>
        <p:xfrm>
          <a:off x="591015" y="1393904"/>
          <a:ext cx="6133170" cy="456084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35772">
                  <a:extLst>
                    <a:ext uri="{9D8B030D-6E8A-4147-A177-3AD203B41FA5}">
                      <a16:colId xmlns:a16="http://schemas.microsoft.com/office/drawing/2014/main" val="3084539396"/>
                    </a:ext>
                  </a:extLst>
                </a:gridCol>
                <a:gridCol w="997363">
                  <a:extLst>
                    <a:ext uri="{9D8B030D-6E8A-4147-A177-3AD203B41FA5}">
                      <a16:colId xmlns:a16="http://schemas.microsoft.com/office/drawing/2014/main" val="984460376"/>
                    </a:ext>
                  </a:extLst>
                </a:gridCol>
                <a:gridCol w="1278805">
                  <a:extLst>
                    <a:ext uri="{9D8B030D-6E8A-4147-A177-3AD203B41FA5}">
                      <a16:colId xmlns:a16="http://schemas.microsoft.com/office/drawing/2014/main" val="2522231649"/>
                    </a:ext>
                  </a:extLst>
                </a:gridCol>
                <a:gridCol w="953702">
                  <a:extLst>
                    <a:ext uri="{9D8B030D-6E8A-4147-A177-3AD203B41FA5}">
                      <a16:colId xmlns:a16="http://schemas.microsoft.com/office/drawing/2014/main" val="1821945958"/>
                    </a:ext>
                  </a:extLst>
                </a:gridCol>
                <a:gridCol w="953702">
                  <a:extLst>
                    <a:ext uri="{9D8B030D-6E8A-4147-A177-3AD203B41FA5}">
                      <a16:colId xmlns:a16="http://schemas.microsoft.com/office/drawing/2014/main" val="2497845275"/>
                    </a:ext>
                  </a:extLst>
                </a:gridCol>
                <a:gridCol w="813826">
                  <a:extLst>
                    <a:ext uri="{9D8B030D-6E8A-4147-A177-3AD203B41FA5}">
                      <a16:colId xmlns:a16="http://schemas.microsoft.com/office/drawing/2014/main" val="1873525564"/>
                    </a:ext>
                  </a:extLst>
                </a:gridCol>
              </a:tblGrid>
              <a:tr h="236488">
                <a:tc gridSpan="6"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pseudo neutralization ID5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6531834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I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se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1.117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13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2809807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570787620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86165007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25676886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62293695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6187355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1436147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3088532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39033130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347700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5989677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34454405"/>
                  </a:ext>
                </a:extLst>
              </a:tr>
              <a:tr h="236488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67395324"/>
                  </a:ext>
                </a:extLst>
              </a:tr>
              <a:tr h="236488"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13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731520" rtl="0" eaLnBrk="1" fontAlgn="b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0346828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24190391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3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.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63246828"/>
                  </a:ext>
                </a:extLst>
              </a:tr>
              <a:tr h="22522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6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04532139"/>
                  </a:ext>
                </a:extLst>
              </a:tr>
              <a:tr h="23648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 mi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10735591"/>
                  </a:ext>
                </a:extLst>
              </a:tr>
              <a:tr h="23648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 max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6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9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0113486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AFA11A3-C93C-4F94-8034-DF8486C319EB}"/>
              </a:ext>
            </a:extLst>
          </p:cNvPr>
          <p:cNvSpPr txBox="1"/>
          <p:nvPr/>
        </p:nvSpPr>
        <p:spPr>
          <a:xfrm>
            <a:off x="490655" y="932239"/>
            <a:ext cx="59212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able S1. ID50 titers of thirteen INO-4800 vaccinee sera against WT/Wuhan and SARS-CoV-2 mutants </a:t>
            </a:r>
            <a:r>
              <a:rPr lang="en-US" sz="1200" dirty="0" err="1"/>
              <a:t>pseudotyped</a:t>
            </a:r>
            <a:r>
              <a:rPr lang="en-US" sz="1200" dirty="0"/>
              <a:t> viruses.   </a:t>
            </a:r>
          </a:p>
        </p:txBody>
      </p:sp>
    </p:spTree>
    <p:extLst>
      <p:ext uri="{BB962C8B-B14F-4D97-AF65-F5344CB8AC3E}">
        <p14:creationId xmlns:p14="http://schemas.microsoft.com/office/powerpoint/2010/main" val="2017574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2F5B9D1-6BE1-4C45-BC7C-FEB7A4EDAD22}"/>
              </a:ext>
            </a:extLst>
          </p:cNvPr>
          <p:cNvSpPr txBox="1"/>
          <p:nvPr/>
        </p:nvSpPr>
        <p:spPr>
          <a:xfrm>
            <a:off x="63936" y="198841"/>
            <a:ext cx="4064254" cy="4440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86" dirty="0"/>
              <a:t>Figure S1 – VOC design-selectio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BC02211-3A44-418B-AF48-9FB44927C153}"/>
              </a:ext>
            </a:extLst>
          </p:cNvPr>
          <p:cNvSpPr txBox="1"/>
          <p:nvPr/>
        </p:nvSpPr>
        <p:spPr>
          <a:xfrm>
            <a:off x="63936" y="6732534"/>
            <a:ext cx="7326706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. Schematic diagram and molecular modeling of SARS-CoV-2 spike protein. A) Spike protein diagram with major features labeled: N-terminal domain (NTD, red), receptor binding domain (RBD, orange), fusion peptide (FP, green), heptad repeats 1 and 2 (HR1 and HR2, blue), transmembrane region (TM, violet), C-terminal domain (CT, dark purple). B) Molecular models of spike protein with mutations indicated for B.1.1.7, B.1.351, and P.1 variants. Trimer model is depicted with one subunit as a Ca trace and colored identically to the diagram in (A) with the two subunits outlined for clarity. Large loops not modeled are indicated by dashed lines and the stalk and membrane-spanning portion of the molecule are indicated with cylinders.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19A4F48-3FB0-45DC-81F3-190190AE4C0C}"/>
              </a:ext>
            </a:extLst>
          </p:cNvPr>
          <p:cNvGrpSpPr/>
          <p:nvPr/>
        </p:nvGrpSpPr>
        <p:grpSpPr>
          <a:xfrm>
            <a:off x="100548" y="1268135"/>
            <a:ext cx="7114103" cy="1148049"/>
            <a:chOff x="1704343" y="593910"/>
            <a:chExt cx="9097489" cy="1699870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12EAB530-1784-458C-82EB-DF126034BF54}"/>
                </a:ext>
              </a:extLst>
            </p:cNvPr>
            <p:cNvSpPr/>
            <p:nvPr/>
          </p:nvSpPr>
          <p:spPr>
            <a:xfrm>
              <a:off x="9614165" y="1410473"/>
              <a:ext cx="626102" cy="570451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BF219948-AF4E-4198-9A68-65D61D95BEB4}"/>
                </a:ext>
              </a:extLst>
            </p:cNvPr>
            <p:cNvSpPr/>
            <p:nvPr/>
          </p:nvSpPr>
          <p:spPr>
            <a:xfrm>
              <a:off x="9024794" y="1407336"/>
              <a:ext cx="626103" cy="570451"/>
            </a:xfrm>
            <a:prstGeom prst="rect">
              <a:avLst/>
            </a:prstGeom>
            <a:solidFill>
              <a:srgbClr val="1F2AFD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27450F23-6829-445C-B7F5-5B20B8DEED61}"/>
                </a:ext>
              </a:extLst>
            </p:cNvPr>
            <p:cNvSpPr/>
            <p:nvPr/>
          </p:nvSpPr>
          <p:spPr>
            <a:xfrm>
              <a:off x="10111358" y="1411829"/>
              <a:ext cx="367480" cy="570451"/>
            </a:xfrm>
            <a:prstGeom prst="rect">
              <a:avLst/>
            </a:prstGeom>
            <a:solidFill>
              <a:srgbClr val="2F1444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7BFC66FB-B209-40AF-80C7-E562AEE20D67}"/>
                </a:ext>
              </a:extLst>
            </p:cNvPr>
            <p:cNvSpPr/>
            <p:nvPr/>
          </p:nvSpPr>
          <p:spPr>
            <a:xfrm>
              <a:off x="1882690" y="1411829"/>
              <a:ext cx="109812" cy="570451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702BA54-EE58-4417-9D95-0D79650178FB}"/>
                </a:ext>
              </a:extLst>
            </p:cNvPr>
            <p:cNvSpPr/>
            <p:nvPr/>
          </p:nvSpPr>
          <p:spPr>
            <a:xfrm>
              <a:off x="1979802" y="1411829"/>
              <a:ext cx="1935758" cy="570451"/>
            </a:xfrm>
            <a:prstGeom prst="rect">
              <a:avLst/>
            </a:prstGeom>
            <a:solidFill>
              <a:srgbClr val="F34B4B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07C97C48-1F88-4104-ABCE-38619F7CDCA5}"/>
                </a:ext>
              </a:extLst>
            </p:cNvPr>
            <p:cNvSpPr/>
            <p:nvPr/>
          </p:nvSpPr>
          <p:spPr>
            <a:xfrm>
              <a:off x="3896575" y="1411829"/>
              <a:ext cx="318766" cy="570451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EB5DEE89-8020-4F55-A61F-F574185E1642}"/>
                </a:ext>
              </a:extLst>
            </p:cNvPr>
            <p:cNvSpPr/>
            <p:nvPr/>
          </p:nvSpPr>
          <p:spPr>
            <a:xfrm>
              <a:off x="4146975" y="1411829"/>
              <a:ext cx="1442906" cy="570451"/>
            </a:xfrm>
            <a:prstGeom prst="rect">
              <a:avLst/>
            </a:prstGeom>
            <a:solidFill>
              <a:srgbClr val="F29344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16F333D-50F2-41C0-951B-90C69714733B}"/>
                </a:ext>
              </a:extLst>
            </p:cNvPr>
            <p:cNvSpPr/>
            <p:nvPr/>
          </p:nvSpPr>
          <p:spPr>
            <a:xfrm>
              <a:off x="5581939" y="1411829"/>
              <a:ext cx="760267" cy="570451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D8877720-D8AE-4540-8FD1-E84FC238DC6E}"/>
                </a:ext>
              </a:extLst>
            </p:cNvPr>
            <p:cNvSpPr/>
            <p:nvPr/>
          </p:nvSpPr>
          <p:spPr>
            <a:xfrm>
              <a:off x="7206597" y="1411829"/>
              <a:ext cx="539406" cy="570451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2AF7411-45E8-40CE-9C92-2DC8CF1E4094}"/>
                </a:ext>
              </a:extLst>
            </p:cNvPr>
            <p:cNvSpPr/>
            <p:nvPr/>
          </p:nvSpPr>
          <p:spPr>
            <a:xfrm>
              <a:off x="8582271" y="1411829"/>
              <a:ext cx="521937" cy="570451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07418E0-BA52-4D8F-83CB-8D4E5FE92D9B}"/>
                </a:ext>
              </a:extLst>
            </p:cNvPr>
            <p:cNvSpPr txBox="1"/>
            <p:nvPr/>
          </p:nvSpPr>
          <p:spPr>
            <a:xfrm>
              <a:off x="2522702" y="1492731"/>
              <a:ext cx="639984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D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2613ACC-7B38-4444-9789-CFB4D3501A87}"/>
                </a:ext>
              </a:extLst>
            </p:cNvPr>
            <p:cNvSpPr txBox="1"/>
            <p:nvPr/>
          </p:nvSpPr>
          <p:spPr>
            <a:xfrm>
              <a:off x="4508722" y="1492731"/>
              <a:ext cx="660483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BD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717761FA-0344-4BCC-9C77-CF658A3155DA}"/>
                </a:ext>
              </a:extLst>
            </p:cNvPr>
            <p:cNvSpPr/>
            <p:nvPr/>
          </p:nvSpPr>
          <p:spPr>
            <a:xfrm>
              <a:off x="6444920" y="1411829"/>
              <a:ext cx="892336" cy="570451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7897890B-F551-48A0-8A03-9F96C776D1B9}"/>
                </a:ext>
              </a:extLst>
            </p:cNvPr>
            <p:cNvSpPr/>
            <p:nvPr/>
          </p:nvSpPr>
          <p:spPr>
            <a:xfrm>
              <a:off x="7717812" y="1411829"/>
              <a:ext cx="412905" cy="570451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D3AC7E1-79A1-420B-8823-522523EB71F3}"/>
                </a:ext>
              </a:extLst>
            </p:cNvPr>
            <p:cNvSpPr txBox="1"/>
            <p:nvPr/>
          </p:nvSpPr>
          <p:spPr>
            <a:xfrm>
              <a:off x="7274016" y="1492731"/>
              <a:ext cx="488290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P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8A7C62A-06D4-45CB-88F6-A24225B30230}"/>
                </a:ext>
              </a:extLst>
            </p:cNvPr>
            <p:cNvSpPr txBox="1"/>
            <p:nvPr/>
          </p:nvSpPr>
          <p:spPr>
            <a:xfrm>
              <a:off x="9033407" y="1492731"/>
              <a:ext cx="627684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R2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E1BD202C-79F3-4836-B388-062C27126A6F}"/>
                </a:ext>
              </a:extLst>
            </p:cNvPr>
            <p:cNvCxnSpPr/>
            <p:nvPr/>
          </p:nvCxnSpPr>
          <p:spPr>
            <a:xfrm>
              <a:off x="1879150" y="660400"/>
              <a:ext cx="4559657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74EE517B-83E0-43AA-A75D-D771C8152B7F}"/>
                </a:ext>
              </a:extLst>
            </p:cNvPr>
            <p:cNvCxnSpPr>
              <a:cxnSpLocks/>
            </p:cNvCxnSpPr>
            <p:nvPr/>
          </p:nvCxnSpPr>
          <p:spPr>
            <a:xfrm>
              <a:off x="6438807" y="660400"/>
              <a:ext cx="404266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D2B05D7A-57A1-42CB-A790-2EA5966AB9DD}"/>
                </a:ext>
              </a:extLst>
            </p:cNvPr>
            <p:cNvCxnSpPr>
              <a:cxnSpLocks/>
            </p:cNvCxnSpPr>
            <p:nvPr/>
          </p:nvCxnSpPr>
          <p:spPr>
            <a:xfrm>
              <a:off x="1883406" y="657741"/>
              <a:ext cx="0" cy="235824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7B92665-FBA5-4516-A79C-C102C0ACA2D5}"/>
                </a:ext>
              </a:extLst>
            </p:cNvPr>
            <p:cNvCxnSpPr>
              <a:cxnSpLocks/>
            </p:cNvCxnSpPr>
            <p:nvPr/>
          </p:nvCxnSpPr>
          <p:spPr>
            <a:xfrm>
              <a:off x="6430958" y="660400"/>
              <a:ext cx="0" cy="235824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7016F9CF-C095-48E2-9D73-3E5596B738C5}"/>
                </a:ext>
              </a:extLst>
            </p:cNvPr>
            <p:cNvCxnSpPr>
              <a:cxnSpLocks/>
            </p:cNvCxnSpPr>
            <p:nvPr/>
          </p:nvCxnSpPr>
          <p:spPr>
            <a:xfrm>
              <a:off x="10475760" y="648968"/>
              <a:ext cx="0" cy="235824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AAA7356-0275-4D87-A2DE-9393740B7588}"/>
                </a:ext>
              </a:extLst>
            </p:cNvPr>
            <p:cNvSpPr txBox="1"/>
            <p:nvPr/>
          </p:nvSpPr>
          <p:spPr>
            <a:xfrm>
              <a:off x="3747133" y="598430"/>
              <a:ext cx="569388" cy="410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44295C7-2305-4E10-9A04-D8CF57D912C3}"/>
                </a:ext>
              </a:extLst>
            </p:cNvPr>
            <p:cNvSpPr txBox="1"/>
            <p:nvPr/>
          </p:nvSpPr>
          <p:spPr>
            <a:xfrm>
              <a:off x="8227573" y="593910"/>
              <a:ext cx="569388" cy="410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2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82CD85D8-82CD-416F-827F-C8C28621E2B9}"/>
                </a:ext>
              </a:extLst>
            </p:cNvPr>
            <p:cNvSpPr/>
            <p:nvPr/>
          </p:nvSpPr>
          <p:spPr>
            <a:xfrm>
              <a:off x="6331979" y="1409975"/>
              <a:ext cx="166383" cy="570451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517215F8-14EA-4636-B61F-9EA019B3E8DF}"/>
                </a:ext>
              </a:extLst>
            </p:cNvPr>
            <p:cNvSpPr/>
            <p:nvPr/>
          </p:nvSpPr>
          <p:spPr>
            <a:xfrm>
              <a:off x="10019367" y="1492731"/>
              <a:ext cx="498539" cy="4101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</a:t>
              </a:r>
              <a:endParaRPr lang="en-US" sz="1200" dirty="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0D839586-EED6-4AA6-935E-31AF8E8E6924}"/>
                </a:ext>
              </a:extLst>
            </p:cNvPr>
            <p:cNvSpPr/>
            <p:nvPr/>
          </p:nvSpPr>
          <p:spPr>
            <a:xfrm>
              <a:off x="8050456" y="1411829"/>
              <a:ext cx="539406" cy="570451"/>
            </a:xfrm>
            <a:prstGeom prst="rect">
              <a:avLst/>
            </a:prstGeom>
            <a:solidFill>
              <a:srgbClr val="1F2AFD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F8D3843-0AD5-465B-880C-553353301CCF}"/>
                </a:ext>
              </a:extLst>
            </p:cNvPr>
            <p:cNvSpPr txBox="1"/>
            <p:nvPr/>
          </p:nvSpPr>
          <p:spPr>
            <a:xfrm>
              <a:off x="7990417" y="1492731"/>
              <a:ext cx="627684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R1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1E249E1-A8CF-4750-B500-D64EADB75C3F}"/>
                </a:ext>
              </a:extLst>
            </p:cNvPr>
            <p:cNvSpPr/>
            <p:nvPr/>
          </p:nvSpPr>
          <p:spPr>
            <a:xfrm>
              <a:off x="9692386" y="1413380"/>
              <a:ext cx="375362" cy="570451"/>
            </a:xfrm>
            <a:prstGeom prst="rect">
              <a:avLst/>
            </a:prstGeom>
            <a:solidFill>
              <a:srgbClr val="B40EFF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562272D-EF69-47C9-A6D3-3CAFB52B4F6B}"/>
                </a:ext>
              </a:extLst>
            </p:cNvPr>
            <p:cNvSpPr/>
            <p:nvPr/>
          </p:nvSpPr>
          <p:spPr>
            <a:xfrm>
              <a:off x="9602598" y="1492731"/>
              <a:ext cx="521089" cy="4101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</a:t>
              </a:r>
              <a:endParaRPr lang="en-US" sz="12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7349F2C7-96DE-40FE-ACBE-4981A2CE09EE}"/>
                </a:ext>
              </a:extLst>
            </p:cNvPr>
            <p:cNvSpPr/>
            <p:nvPr/>
          </p:nvSpPr>
          <p:spPr>
            <a:xfrm>
              <a:off x="1704343" y="1253198"/>
              <a:ext cx="8923547" cy="186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AC6509F-8D3C-4AD2-84CB-EC0318ADD128}"/>
                </a:ext>
              </a:extLst>
            </p:cNvPr>
            <p:cNvSpPr txBox="1"/>
            <p:nvPr/>
          </p:nvSpPr>
          <p:spPr>
            <a:xfrm>
              <a:off x="1722675" y="1094107"/>
              <a:ext cx="34479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57899E9-A56F-412E-8278-B2D6E0C58703}"/>
                </a:ext>
              </a:extLst>
            </p:cNvPr>
            <p:cNvSpPr txBox="1"/>
            <p:nvPr/>
          </p:nvSpPr>
          <p:spPr>
            <a:xfrm>
              <a:off x="3894571" y="1094107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3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018D20D-FB8A-4616-9FDF-0E6503DA97C5}"/>
                </a:ext>
              </a:extLst>
            </p:cNvPr>
            <p:cNvSpPr txBox="1"/>
            <p:nvPr/>
          </p:nvSpPr>
          <p:spPr>
            <a:xfrm>
              <a:off x="6142704" y="1094107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86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85F0C3D-7BC0-4C54-9A72-C6756C0187A6}"/>
                </a:ext>
              </a:extLst>
            </p:cNvPr>
            <p:cNvSpPr txBox="1"/>
            <p:nvPr/>
          </p:nvSpPr>
          <p:spPr>
            <a:xfrm>
              <a:off x="8253994" y="1094107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7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FF62999-7953-4CFC-87F5-4E53C9631468}"/>
                </a:ext>
              </a:extLst>
            </p:cNvPr>
            <p:cNvSpPr txBox="1"/>
            <p:nvPr/>
          </p:nvSpPr>
          <p:spPr>
            <a:xfrm>
              <a:off x="9192727" y="1094107"/>
              <a:ext cx="670733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02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175E342-AC3F-40D9-9637-215664E41893}"/>
                </a:ext>
              </a:extLst>
            </p:cNvPr>
            <p:cNvSpPr txBox="1"/>
            <p:nvPr/>
          </p:nvSpPr>
          <p:spPr>
            <a:xfrm>
              <a:off x="7433118" y="1094107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55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BE5EE9B2-4C15-43C9-B287-0E56AA9607FA}"/>
                </a:ext>
              </a:extLst>
            </p:cNvPr>
            <p:cNvSpPr/>
            <p:nvPr/>
          </p:nvSpPr>
          <p:spPr>
            <a:xfrm>
              <a:off x="1787016" y="1912639"/>
              <a:ext cx="8923547" cy="186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CEF9976-45ED-4498-BC04-296883A4B5DE}"/>
                </a:ext>
              </a:extLst>
            </p:cNvPr>
            <p:cNvSpPr txBox="1"/>
            <p:nvPr/>
          </p:nvSpPr>
          <p:spPr>
            <a:xfrm>
              <a:off x="3601408" y="1883639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06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663E288-0DAA-43DE-AA73-932871FBCC49}"/>
                </a:ext>
              </a:extLst>
            </p:cNvPr>
            <p:cNvSpPr txBox="1"/>
            <p:nvPr/>
          </p:nvSpPr>
          <p:spPr>
            <a:xfrm>
              <a:off x="5292419" y="1883639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28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6CF4099-7893-44CC-A4B4-1A7E8B3E7827}"/>
                </a:ext>
              </a:extLst>
            </p:cNvPr>
            <p:cNvSpPr txBox="1"/>
            <p:nvPr/>
          </p:nvSpPr>
          <p:spPr>
            <a:xfrm>
              <a:off x="7050441" y="1883639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1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FC61D34-C1EA-4F0C-B759-A7A41609F047}"/>
                </a:ext>
              </a:extLst>
            </p:cNvPr>
            <p:cNvSpPr txBox="1"/>
            <p:nvPr/>
          </p:nvSpPr>
          <p:spPr>
            <a:xfrm>
              <a:off x="8725844" y="1883639"/>
              <a:ext cx="659909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163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4D4AF16-B484-4E58-9B84-FFE276907DC1}"/>
                </a:ext>
              </a:extLst>
            </p:cNvPr>
            <p:cNvSpPr txBox="1"/>
            <p:nvPr/>
          </p:nvSpPr>
          <p:spPr>
            <a:xfrm>
              <a:off x="10131099" y="1883639"/>
              <a:ext cx="670733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73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1734F74-BB1A-4051-8CB7-26B56752287E}"/>
                </a:ext>
              </a:extLst>
            </p:cNvPr>
            <p:cNvSpPr txBox="1"/>
            <p:nvPr/>
          </p:nvSpPr>
          <p:spPr>
            <a:xfrm>
              <a:off x="9836967" y="1094106"/>
              <a:ext cx="670733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34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21ADA56-7A77-40E5-BFC0-67D28DF25C3E}"/>
                </a:ext>
              </a:extLst>
            </p:cNvPr>
            <p:cNvSpPr txBox="1"/>
            <p:nvPr/>
          </p:nvSpPr>
          <p:spPr>
            <a:xfrm>
              <a:off x="7743518" y="1883639"/>
              <a:ext cx="562087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2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0B26CBB-A074-4D04-BF11-49EB62C9BD0E}"/>
                </a:ext>
              </a:extLst>
            </p:cNvPr>
            <p:cNvSpPr txBox="1"/>
            <p:nvPr/>
          </p:nvSpPr>
          <p:spPr>
            <a:xfrm>
              <a:off x="9391926" y="1883639"/>
              <a:ext cx="670733" cy="4101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14</a:t>
              </a:r>
            </a:p>
          </p:txBody>
        </p:sp>
      </p:grpSp>
      <p:pic>
        <p:nvPicPr>
          <p:cNvPr id="54" name="Picture 53">
            <a:extLst>
              <a:ext uri="{FF2B5EF4-FFF2-40B4-BE49-F238E27FC236}">
                <a16:creationId xmlns:a16="http://schemas.microsoft.com/office/drawing/2014/main" id="{FA48595D-4529-4743-B9A9-63D903059E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103" y="3165507"/>
            <a:ext cx="7094954" cy="3086671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DBC0AC10-85F1-4B86-9FB7-9D7E8285F65E}"/>
              </a:ext>
            </a:extLst>
          </p:cNvPr>
          <p:cNvSpPr txBox="1"/>
          <p:nvPr/>
        </p:nvSpPr>
        <p:spPr>
          <a:xfrm>
            <a:off x="60397" y="63880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9FFD62B-FE44-4F30-BA3B-3BE71A78ECB1}"/>
              </a:ext>
            </a:extLst>
          </p:cNvPr>
          <p:cNvSpPr txBox="1"/>
          <p:nvPr/>
        </p:nvSpPr>
        <p:spPr>
          <a:xfrm>
            <a:off x="56424" y="252223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10263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0</TotalTime>
  <Words>319</Words>
  <Application>Microsoft Office PowerPoint</Application>
  <PresentationFormat>Custom</PresentationFormat>
  <Paragraphs>13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iane Machado</dc:creator>
  <cp:lastModifiedBy>Viviane Machado</cp:lastModifiedBy>
  <cp:revision>71</cp:revision>
  <dcterms:created xsi:type="dcterms:W3CDTF">2021-03-01T18:26:46Z</dcterms:created>
  <dcterms:modified xsi:type="dcterms:W3CDTF">2021-04-13T23:49:24Z</dcterms:modified>
</cp:coreProperties>
</file>